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changesInfos/changesInfo1.xml" ContentType="application/vnd.ms-powerpoint.changes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58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995" autoAdjust="0"/>
    <p:restoredTop sz="94915" autoAdjust="0"/>
  </p:normalViewPr>
  <p:slideViewPr>
    <p:cSldViewPr snapToGrid="0">
      <p:cViewPr varScale="1">
        <p:scale>
          <a:sx n="97" d="100"/>
          <a:sy n="97" d="100"/>
        </p:scale>
        <p:origin x="4422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Ottmar Janssen" userId="70344527451028a5" providerId="LiveId" clId="{87757E83-94D6-48C3-9F6B-0FCDCD190C12}"/>
    <pc:docChg chg="modSld">
      <pc:chgData name="Ottmar Janssen" userId="70344527451028a5" providerId="LiveId" clId="{87757E83-94D6-48C3-9F6B-0FCDCD190C12}" dt="2024-10-16T13:34:37.086" v="1" actId="20577"/>
      <pc:docMkLst>
        <pc:docMk/>
      </pc:docMkLst>
      <pc:sldChg chg="modSp mod">
        <pc:chgData name="Ottmar Janssen" userId="70344527451028a5" providerId="LiveId" clId="{87757E83-94D6-48C3-9F6B-0FCDCD190C12}" dt="2024-10-16T13:34:37.086" v="1" actId="20577"/>
        <pc:sldMkLst>
          <pc:docMk/>
          <pc:sldMk cId="975866060" sldId="258"/>
        </pc:sldMkLst>
        <pc:spChg chg="mod">
          <ac:chgData name="Ottmar Janssen" userId="70344527451028a5" providerId="LiveId" clId="{87757E83-94D6-48C3-9F6B-0FCDCD190C12}" dt="2024-10-16T13:34:37.086" v="1" actId="20577"/>
          <ac:spMkLst>
            <pc:docMk/>
            <pc:sldMk cId="975866060" sldId="258"/>
            <ac:spMk id="35" creationId="{CE215443-3496-AB66-8F73-DA56893A056F}"/>
          </ac:spMkLst>
        </pc:spChg>
      </pc:sldChg>
    </pc:docChg>
  </pc:docChgLst>
  <pc:docChgLst>
    <pc:chgData name="Ottmar Janssen" userId="70344527451028a5" providerId="LiveId" clId="{15EAB259-B585-4490-B8ED-8B7F29D8AD74}"/>
    <pc:docChg chg="undo custSel modSld">
      <pc:chgData name="Ottmar Janssen" userId="70344527451028a5" providerId="LiveId" clId="{15EAB259-B585-4490-B8ED-8B7F29D8AD74}" dt="2024-09-11T10:16:39.008" v="1047" actId="123"/>
      <pc:docMkLst>
        <pc:docMk/>
      </pc:docMkLst>
      <pc:sldChg chg="addSp delSp modSp mod">
        <pc:chgData name="Ottmar Janssen" userId="70344527451028a5" providerId="LiveId" clId="{15EAB259-B585-4490-B8ED-8B7F29D8AD74}" dt="2024-09-11T10:16:39.008" v="1047" actId="123"/>
        <pc:sldMkLst>
          <pc:docMk/>
          <pc:sldMk cId="975866060" sldId="258"/>
        </pc:sldMkLst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5" creationId="{C8ED4D79-2A3D-4780-DEE5-4CD515FA06CF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6" creationId="{F45B540E-26A6-1013-5F22-8347535393C4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12" creationId="{F6D770AB-3D40-3158-94E0-BBDCED477A32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13" creationId="{539CA96D-9B93-34C0-6397-73063CD4FD16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17" creationId="{958C2590-BE3A-7905-0455-07B5C32A9D8B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18" creationId="{15F3FC46-BEE2-3382-95DB-E313FC814A48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20" creationId="{539CA96D-9B93-34C0-6397-73063CD4FD16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21" creationId="{958C2590-BE3A-7905-0455-07B5C32A9D8B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22" creationId="{15F3FC46-BEE2-3382-95DB-E313FC814A48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26" creationId="{C8ED4D79-2A3D-4780-DEE5-4CD515FA06CF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27" creationId="{F6D770AB-3D40-3158-94E0-BBDCED477A32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28" creationId="{F45B540E-26A6-1013-5F22-8347535393C4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29" creationId="{648982B1-53DF-6120-50A6-36829BAF92AB}"/>
          </ac:spMkLst>
        </pc:spChg>
        <pc:spChg chg="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33" creationId="{3F9B2866-14EA-13F4-AE0B-AF011205CC1C}"/>
          </ac:spMkLst>
        </pc:spChg>
        <pc:spChg chg="add mod">
          <ac:chgData name="Ottmar Janssen" userId="70344527451028a5" providerId="LiveId" clId="{15EAB259-B585-4490-B8ED-8B7F29D8AD74}" dt="2024-09-11T10:16:39.008" v="1047" actId="123"/>
          <ac:spMkLst>
            <pc:docMk/>
            <pc:sldMk cId="975866060" sldId="258"/>
            <ac:spMk id="35" creationId="{CE215443-3496-AB66-8F73-DA56893A056F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39" creationId="{648982B1-53DF-6120-50A6-36829BAF92AB}"/>
          </ac:spMkLst>
        </pc:spChg>
        <pc:spChg chg="mod topLvl">
          <ac:chgData name="Ottmar Janssen" userId="70344527451028a5" providerId="LiveId" clId="{15EAB259-B585-4490-B8ED-8B7F29D8AD74}" dt="2024-09-05T10:35:04.661" v="368" actId="404"/>
          <ac:spMkLst>
            <pc:docMk/>
            <pc:sldMk cId="975866060" sldId="258"/>
            <ac:spMk id="40" creationId="{3F9B2866-14EA-13F4-AE0B-AF011205CC1C}"/>
          </ac:spMkLst>
        </pc:spChg>
        <pc:grpChg chg="add del mod">
          <ac:chgData name="Ottmar Janssen" userId="70344527451028a5" providerId="LiveId" clId="{15EAB259-B585-4490-B8ED-8B7F29D8AD74}" dt="2024-09-05T10:35:11.281" v="369" actId="21"/>
          <ac:grpSpMkLst>
            <pc:docMk/>
            <pc:sldMk cId="975866060" sldId="258"/>
            <ac:grpSpMk id="2" creationId="{74A6BF7D-489D-3C19-A688-79E108FAD007}"/>
          </ac:grpSpMkLst>
        </pc:grpChg>
        <pc:grpChg chg="add del mod">
          <ac:chgData name="Ottmar Janssen" userId="70344527451028a5" providerId="LiveId" clId="{15EAB259-B585-4490-B8ED-8B7F29D8AD74}" dt="2024-09-05T09:06:41.361" v="135" actId="165"/>
          <ac:grpSpMkLst>
            <pc:docMk/>
            <pc:sldMk cId="975866060" sldId="258"/>
            <ac:grpSpMk id="2" creationId="{D778A1EB-5037-E2CF-DEAA-EA0AD60388E4}"/>
          </ac:grpSpMkLst>
        </pc:grpChg>
        <pc:grpChg chg="add mod">
          <ac:chgData name="Ottmar Janssen" userId="70344527451028a5" providerId="LiveId" clId="{15EAB259-B585-4490-B8ED-8B7F29D8AD74}" dt="2024-09-05T10:35:51.669" v="371" actId="1076"/>
          <ac:grpSpMkLst>
            <pc:docMk/>
            <pc:sldMk cId="975866060" sldId="258"/>
            <ac:grpSpMk id="3" creationId="{74A6BF7D-489D-3C19-A688-79E108FAD007}"/>
          </ac:grpSpMkLst>
        </pc:grp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4" creationId="{06407334-41A4-80EF-A163-B250122C9E5E}"/>
          </ac:picMkLst>
        </pc:pic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7" creationId="{0A33DEEF-B6DF-7E12-292C-EC7588C2F077}"/>
          </ac:picMkLst>
        </pc:pic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8" creationId="{19714768-D0D9-77D7-0B46-C69E05ECE1D7}"/>
          </ac:picMkLst>
        </pc:pic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9" creationId="{7EB5D1B8-ED13-A4B6-508D-6E0BAD294DF6}"/>
          </ac:picMkLst>
        </pc:pic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10" creationId="{F709502E-9658-16E9-E1B5-F4DB0B030066}"/>
          </ac:picMkLst>
        </pc:picChg>
        <pc:picChg chg="mod">
          <ac:chgData name="Ottmar Janssen" userId="70344527451028a5" providerId="LiveId" clId="{15EAB259-B585-4490-B8ED-8B7F29D8AD74}" dt="2024-09-05T10:35:45.762" v="370"/>
          <ac:picMkLst>
            <pc:docMk/>
            <pc:sldMk cId="975866060" sldId="258"/>
            <ac:picMk id="11" creationId="{D2CA83CF-78BC-4F2C-5A19-EC00BD55BB92}"/>
          </ac:picMkLst>
        </pc:picChg>
        <pc:picChg chg="mod or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23" creationId="{06407334-41A4-80EF-A163-B250122C9E5E}"/>
          </ac:picMkLst>
        </pc:picChg>
        <pc:picChg chg="mod or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24" creationId="{0A33DEEF-B6DF-7E12-292C-EC7588C2F077}"/>
          </ac:picMkLst>
        </pc:picChg>
        <pc:picChg chg="mod or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25" creationId="{19714768-D0D9-77D7-0B46-C69E05ECE1D7}"/>
          </ac:picMkLst>
        </pc:picChg>
        <pc:picChg chg="mo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30" creationId="{7EB5D1B8-ED13-A4B6-508D-6E0BAD294DF6}"/>
          </ac:picMkLst>
        </pc:picChg>
        <pc:picChg chg="mo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31" creationId="{F709502E-9658-16E9-E1B5-F4DB0B030066}"/>
          </ac:picMkLst>
        </pc:picChg>
        <pc:picChg chg="mod topLvl">
          <ac:chgData name="Ottmar Janssen" userId="70344527451028a5" providerId="LiveId" clId="{15EAB259-B585-4490-B8ED-8B7F29D8AD74}" dt="2024-09-05T10:34:49.118" v="362" actId="164"/>
          <ac:picMkLst>
            <pc:docMk/>
            <pc:sldMk cId="975866060" sldId="258"/>
            <ac:picMk id="32" creationId="{D2CA83CF-78BC-4F2C-5A19-EC00BD55BB92}"/>
          </ac:picMkLst>
        </pc:picChg>
        <pc:cxnChg chg="mod">
          <ac:chgData name="Ottmar Janssen" userId="70344527451028a5" providerId="LiveId" clId="{15EAB259-B585-4490-B8ED-8B7F29D8AD74}" dt="2024-09-05T10:35:45.762" v="370"/>
          <ac:cxnSpMkLst>
            <pc:docMk/>
            <pc:sldMk cId="975866060" sldId="258"/>
            <ac:cxnSpMk id="14" creationId="{C189C7DC-1446-8D1A-F9D9-B3D31620C3A0}"/>
          </ac:cxnSpMkLst>
        </pc:cxnChg>
        <pc:cxnChg chg="mod topLvl">
          <ac:chgData name="Ottmar Janssen" userId="70344527451028a5" providerId="LiveId" clId="{15EAB259-B585-4490-B8ED-8B7F29D8AD74}" dt="2024-09-05T10:34:49.118" v="362" actId="164"/>
          <ac:cxnSpMkLst>
            <pc:docMk/>
            <pc:sldMk cId="975866060" sldId="258"/>
            <ac:cxnSpMk id="15" creationId="{C189C7DC-1446-8D1A-F9D9-B3D31620C3A0}"/>
          </ac:cxnSpMkLst>
        </pc:cxnChg>
        <pc:cxnChg chg="mod topLvl">
          <ac:chgData name="Ottmar Janssen" userId="70344527451028a5" providerId="LiveId" clId="{15EAB259-B585-4490-B8ED-8B7F29D8AD74}" dt="2024-09-05T10:34:49.118" v="362" actId="164"/>
          <ac:cxnSpMkLst>
            <pc:docMk/>
            <pc:sldMk cId="975866060" sldId="258"/>
            <ac:cxnSpMk id="16" creationId="{85C30069-8B06-A483-F5E9-7D3D4837165B}"/>
          </ac:cxnSpMkLst>
        </pc:cxnChg>
        <pc:cxnChg chg="mod">
          <ac:chgData name="Ottmar Janssen" userId="70344527451028a5" providerId="LiveId" clId="{15EAB259-B585-4490-B8ED-8B7F29D8AD74}" dt="2024-09-05T10:35:45.762" v="370"/>
          <ac:cxnSpMkLst>
            <pc:docMk/>
            <pc:sldMk cId="975866060" sldId="258"/>
            <ac:cxnSpMk id="19" creationId="{85C30069-8B06-A483-F5E9-7D3D4837165B}"/>
          </ac:cxnSpMkLst>
        </pc:cxnChg>
      </pc:sldChg>
    </pc:docChg>
  </pc:docChgLst>
  <pc:docChgLst>
    <pc:chgData name="Ottmar Janssen" userId="70344527451028a5" providerId="LiveId" clId="{FE343503-40EE-44F4-B500-57E57A0105B8}"/>
    <pc:docChg chg="custSel modSld">
      <pc:chgData name="Ottmar Janssen" userId="70344527451028a5" providerId="LiveId" clId="{FE343503-40EE-44F4-B500-57E57A0105B8}" dt="2024-08-17T14:12:02.611" v="0" actId="478"/>
      <pc:docMkLst>
        <pc:docMk/>
      </pc:docMkLst>
      <pc:sldChg chg="delSp mod">
        <pc:chgData name="Ottmar Janssen" userId="70344527451028a5" providerId="LiveId" clId="{FE343503-40EE-44F4-B500-57E57A0105B8}" dt="2024-08-17T14:12:02.611" v="0" actId="478"/>
        <pc:sldMkLst>
          <pc:docMk/>
          <pc:sldMk cId="975866060" sldId="258"/>
        </pc:sldMkLst>
        <pc:spChg chg="del">
          <ac:chgData name="Ottmar Janssen" userId="70344527451028a5" providerId="LiveId" clId="{FE343503-40EE-44F4-B500-57E57A0105B8}" dt="2024-08-17T14:12:02.611" v="0" actId="478"/>
          <ac:spMkLst>
            <pc:docMk/>
            <pc:sldMk cId="975866060" sldId="258"/>
            <ac:spMk id="12" creationId="{03248B54-5F59-3B50-C00E-53B05BEB13BA}"/>
          </ac:spMkLst>
        </pc:spChg>
      </pc:sldChg>
    </pc:docChg>
  </pc:docChgLst>
  <pc:docChgLst>
    <pc:chgData name="Ottmar Janssen" userId="70344527451028a5" providerId="LiveId" clId="{D81278BD-CC1D-4DFB-AA59-3B086819785F}"/>
    <pc:docChg chg="delSld">
      <pc:chgData name="Ottmar Janssen" userId="70344527451028a5" providerId="LiveId" clId="{D81278BD-CC1D-4DFB-AA59-3B086819785F}" dt="2024-08-16T10:24:37.719" v="0" actId="47"/>
      <pc:docMkLst>
        <pc:docMk/>
      </pc:docMkLst>
      <pc:sldChg chg="del">
        <pc:chgData name="Ottmar Janssen" userId="70344527451028a5" providerId="LiveId" clId="{D81278BD-CC1D-4DFB-AA59-3B086819785F}" dt="2024-08-16T10:24:37.719" v="0" actId="47"/>
        <pc:sldMkLst>
          <pc:docMk/>
          <pc:sldMk cId="3163140662" sldId="259"/>
        </pc:sldMkLst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BFF8F20-8999-4EFD-959D-634BF2160D47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C2B498C-F3F1-4244-9297-EA0517C4C12D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86729520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>
          <a:xfrm>
            <a:off x="2360613" y="1143000"/>
            <a:ext cx="2136775" cy="3086100"/>
          </a:xfrm>
        </p:spPr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7C2B498C-F3F1-4244-9297-EA0517C4C12D}" type="slidenum">
              <a:rPr lang="de-DE" smtClean="0"/>
              <a:t>1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9791341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de-DE"/>
              <a:t>Master-Untertitelformat bearbeiten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51833155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el und vertikaler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3765817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kaler Titel u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0693865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el und Inhal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634209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Abschnitts-&#10;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>
                    <a:tint val="82000"/>
                  </a:schemeClr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82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82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82000"/>
                  </a:schemeClr>
                </a:solidFill>
              </a:defRPr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25509622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Zwei Inhal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87045320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Vergleic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415437073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Nur Ti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687785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Le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277048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Inhalt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0012416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Bild mit Überschrif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de-DE"/>
              <a:t>Bild durch Klicken auf Symbol hinzufügen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de-DE"/>
              <a:t>Mastertextformat bearbeiten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de-D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5201906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de-DE"/>
              <a:t>Mastertitelformat bearbeiten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de-DE"/>
              <a:t>Mastertextformat bearbeiten</a:t>
            </a:r>
          </a:p>
          <a:p>
            <a:pPr lvl="1"/>
            <a:r>
              <a:rPr lang="de-DE"/>
              <a:t>Zweite Ebene</a:t>
            </a:r>
          </a:p>
          <a:p>
            <a:pPr lvl="2"/>
            <a:r>
              <a:rPr lang="de-DE"/>
              <a:t>Dritte Ebene</a:t>
            </a:r>
          </a:p>
          <a:p>
            <a:pPr lvl="3"/>
            <a:r>
              <a:rPr lang="de-DE"/>
              <a:t>Vierte Ebene</a:t>
            </a:r>
          </a:p>
          <a:p>
            <a:pPr lvl="4"/>
            <a:r>
              <a:rPr lang="de-DE"/>
              <a:t>Fünfte Eben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C01C2D35-0CB1-473F-A054-F29FEEDB5B54}" type="datetimeFigureOut">
              <a:rPr lang="de-DE" smtClean="0"/>
              <a:t>16.10.2024</a:t>
            </a:fld>
            <a:endParaRPr lang="de-D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endParaRPr lang="de-D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82000"/>
                  </a:schemeClr>
                </a:solidFill>
              </a:defRPr>
            </a:lvl1pPr>
          </a:lstStyle>
          <a:p>
            <a:fld id="{39465655-E272-4D41-8242-930000BFCFCC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21835605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4.png"/><Relationship Id="rId5" Type="http://schemas.openxmlformats.org/officeDocument/2006/relationships/image" Target="../media/image3.png"/><Relationship Id="rId4" Type="http://schemas.openxmlformats.org/officeDocument/2006/relationships/image" Target="../media/image2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uppieren 2">
            <a:extLst>
              <a:ext uri="{FF2B5EF4-FFF2-40B4-BE49-F238E27FC236}">
                <a16:creationId xmlns:a16="http://schemas.microsoft.com/office/drawing/2014/main" id="{74A6BF7D-489D-3C19-A688-79E108FAD007}"/>
              </a:ext>
            </a:extLst>
          </p:cNvPr>
          <p:cNvGrpSpPr/>
          <p:nvPr/>
        </p:nvGrpSpPr>
        <p:grpSpPr>
          <a:xfrm>
            <a:off x="379088" y="901893"/>
            <a:ext cx="6099823" cy="4051107"/>
            <a:chOff x="969759" y="342928"/>
            <a:chExt cx="9574416" cy="5292389"/>
          </a:xfrm>
        </p:grpSpPr>
        <p:pic>
          <p:nvPicPr>
            <p:cNvPr id="4" name="Grafik 3" descr="Ein Bild, das Screenshot, Tex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06407334-41A4-80EF-A163-B250122C9E5E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3"/>
            <a:srcRect l="59287" t="33961" r="6107" b="27478"/>
            <a:stretch/>
          </p:blipFill>
          <p:spPr>
            <a:xfrm>
              <a:off x="1617061" y="2762094"/>
              <a:ext cx="2832436" cy="2359287"/>
            </a:xfrm>
            <a:prstGeom prst="rect">
              <a:avLst/>
            </a:prstGeom>
          </p:spPr>
        </p:pic>
        <p:pic>
          <p:nvPicPr>
            <p:cNvPr id="7" name="Grafik 6" descr="Ein Bild, das Text, Screensho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0A33DEEF-B6DF-7E12-292C-EC7588C2F07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4">
              <a:alphaModFix/>
            </a:blip>
            <a:srcRect l="59012" t="34084" r="5960" b="28064"/>
            <a:stretch/>
          </p:blipFill>
          <p:spPr>
            <a:xfrm>
              <a:off x="4491337" y="2733020"/>
              <a:ext cx="2832436" cy="2359287"/>
            </a:xfrm>
            <a:prstGeom prst="rect">
              <a:avLst/>
            </a:prstGeom>
          </p:spPr>
        </p:pic>
        <p:pic>
          <p:nvPicPr>
            <p:cNvPr id="8" name="Grafik 7" descr="Ein Bild, das Text, Screensho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19714768-D0D9-77D7-0B46-C69E05ECE1D7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5"/>
            <a:srcRect l="59359" t="33301" r="8551" b="28137"/>
            <a:stretch/>
          </p:blipFill>
          <p:spPr>
            <a:xfrm>
              <a:off x="7369240" y="2733519"/>
              <a:ext cx="2832436" cy="2359287"/>
            </a:xfrm>
            <a:prstGeom prst="rect">
              <a:avLst/>
            </a:prstGeom>
          </p:spPr>
        </p:pic>
        <p:pic>
          <p:nvPicPr>
            <p:cNvPr id="9" name="Grafik 8" descr="Ein Bild, das Text, Screensho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7EB5D1B8-ED13-A4B6-508D-6E0BAD294DF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6"/>
            <a:srcRect l="59256" t="34136" r="8656" b="27760"/>
            <a:stretch/>
          </p:blipFill>
          <p:spPr>
            <a:xfrm>
              <a:off x="1607536" y="487816"/>
              <a:ext cx="2832436" cy="2359287"/>
            </a:xfrm>
            <a:prstGeom prst="rect">
              <a:avLst/>
            </a:prstGeom>
          </p:spPr>
        </p:pic>
        <p:pic>
          <p:nvPicPr>
            <p:cNvPr id="10" name="Grafik 9" descr="Ein Bild, das Text, Screensho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F709502E-9658-16E9-E1B5-F4DB0B030066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7"/>
            <a:srcRect l="59225" t="33582" r="6040" b="27856"/>
            <a:stretch/>
          </p:blipFill>
          <p:spPr>
            <a:xfrm>
              <a:off x="4491337" y="480084"/>
              <a:ext cx="2832436" cy="2359287"/>
            </a:xfrm>
            <a:prstGeom prst="rect">
              <a:avLst/>
            </a:prstGeom>
          </p:spPr>
        </p:pic>
        <p:pic>
          <p:nvPicPr>
            <p:cNvPr id="11" name="Grafik 10" descr="Ein Bild, das Text, Screenshot, Software, Computersymbol enthält.&#10;&#10;Automatisch generierte Beschreibung">
              <a:extLst>
                <a:ext uri="{FF2B5EF4-FFF2-40B4-BE49-F238E27FC236}">
                  <a16:creationId xmlns:a16="http://schemas.microsoft.com/office/drawing/2014/main" id="{D2CA83CF-78BC-4F2C-5A19-EC00BD55BB92}"/>
                </a:ext>
              </a:extLst>
            </p:cNvPr>
            <p:cNvPicPr preferRelativeResize="0">
              <a:picLocks/>
            </p:cNvPicPr>
            <p:nvPr/>
          </p:nvPicPr>
          <p:blipFill rotWithShape="1">
            <a:blip r:embed="rId8"/>
            <a:srcRect l="59310" t="33704" r="8601" b="27735"/>
            <a:stretch/>
          </p:blipFill>
          <p:spPr>
            <a:xfrm>
              <a:off x="7369240" y="431564"/>
              <a:ext cx="2832436" cy="2414639"/>
            </a:xfrm>
            <a:prstGeom prst="rect">
              <a:avLst/>
            </a:prstGeom>
          </p:spPr>
        </p:pic>
        <p:sp>
          <p:nvSpPr>
            <p:cNvPr id="12" name="Textfeld 39">
              <a:extLst>
                <a:ext uri="{FF2B5EF4-FFF2-40B4-BE49-F238E27FC236}">
                  <a16:creationId xmlns:a16="http://schemas.microsoft.com/office/drawing/2014/main" id="{F6D770AB-3D40-3158-94E0-BBDCED477A32}"/>
                </a:ext>
              </a:extLst>
            </p:cNvPr>
            <p:cNvSpPr txBox="1"/>
            <p:nvPr/>
          </p:nvSpPr>
          <p:spPr>
            <a:xfrm>
              <a:off x="1913887" y="544547"/>
              <a:ext cx="2219737" cy="30156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8</a:t>
              </a:r>
              <a:r>
                <a:rPr lang="en-GB" sz="90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 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T cells (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unstim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13" name="Textfeld 44">
              <a:extLst>
                <a:ext uri="{FF2B5EF4-FFF2-40B4-BE49-F238E27FC236}">
                  <a16:creationId xmlns:a16="http://schemas.microsoft.com/office/drawing/2014/main" id="{539CA96D-9B93-34C0-6397-73063CD4FD16}"/>
                </a:ext>
              </a:extLst>
            </p:cNvPr>
            <p:cNvSpPr txBox="1"/>
            <p:nvPr/>
          </p:nvSpPr>
          <p:spPr>
            <a:xfrm>
              <a:off x="1967995" y="2882645"/>
              <a:ext cx="2111518" cy="301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de-DE" sz="900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γδ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T cells (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unstim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 2 h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cxnSp>
          <p:nvCxnSpPr>
            <p:cNvPr id="14" name="Gerade Verbindung 1405762763">
              <a:extLst>
                <a:ext uri="{FF2B5EF4-FFF2-40B4-BE49-F238E27FC236}">
                  <a16:creationId xmlns:a16="http://schemas.microsoft.com/office/drawing/2014/main" id="{C189C7DC-1446-8D1A-F9D9-B3D31620C3A0}"/>
                </a:ext>
              </a:extLst>
            </p:cNvPr>
            <p:cNvCxnSpPr>
              <a:cxnSpLocks/>
            </p:cNvCxnSpPr>
            <p:nvPr/>
          </p:nvCxnSpPr>
          <p:spPr>
            <a:xfrm>
              <a:off x="1397635" y="342928"/>
              <a:ext cx="0" cy="4902994"/>
            </a:xfrm>
            <a:prstGeom prst="line">
              <a:avLst/>
            </a:prstGeom>
            <a:ln>
              <a:head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19" name="Gerade Verbindung 844864466">
              <a:extLst>
                <a:ext uri="{FF2B5EF4-FFF2-40B4-BE49-F238E27FC236}">
                  <a16:creationId xmlns:a16="http://schemas.microsoft.com/office/drawing/2014/main" id="{85C30069-8B06-A483-F5E9-7D3D4837165B}"/>
                </a:ext>
              </a:extLst>
            </p:cNvPr>
            <p:cNvCxnSpPr>
              <a:cxnSpLocks/>
            </p:cNvCxnSpPr>
            <p:nvPr/>
          </p:nvCxnSpPr>
          <p:spPr>
            <a:xfrm>
              <a:off x="1398238" y="5293547"/>
              <a:ext cx="8688737" cy="0"/>
            </a:xfrm>
            <a:prstGeom prst="line">
              <a:avLst/>
            </a:prstGeom>
            <a:ln>
              <a:headEnd type="none"/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21" name="Textfeld 60">
              <a:extLst>
                <a:ext uri="{FF2B5EF4-FFF2-40B4-BE49-F238E27FC236}">
                  <a16:creationId xmlns:a16="http://schemas.microsoft.com/office/drawing/2014/main" id="{958C2590-BE3A-7905-0455-07B5C32A9D8B}"/>
                </a:ext>
              </a:extLst>
            </p:cNvPr>
            <p:cNvSpPr txBox="1"/>
            <p:nvPr/>
          </p:nvSpPr>
          <p:spPr>
            <a:xfrm>
              <a:off x="8181976" y="5293548"/>
              <a:ext cx="2362199" cy="34176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05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</a:t>
              </a:r>
              <a:r>
                <a:rPr lang="en-GB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rticle size (nm)</a:t>
              </a:r>
              <a:endParaRPr lang="de-DE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2" name="Textfeld 61">
              <a:extLst>
                <a:ext uri="{FF2B5EF4-FFF2-40B4-BE49-F238E27FC236}">
                  <a16:creationId xmlns:a16="http://schemas.microsoft.com/office/drawing/2014/main" id="{15F3FC46-BEE2-3382-95DB-E313FC814A48}"/>
                </a:ext>
              </a:extLst>
            </p:cNvPr>
            <p:cNvSpPr txBox="1"/>
            <p:nvPr/>
          </p:nvSpPr>
          <p:spPr>
            <a:xfrm rot="16200000">
              <a:off x="-720817" y="2122140"/>
              <a:ext cx="3791781" cy="410629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just"/>
              <a:r>
                <a:rPr lang="en-GB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oncentration (x 10</a:t>
              </a:r>
              <a:r>
                <a:rPr lang="en-GB" sz="105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9</a:t>
              </a:r>
              <a:r>
                <a:rPr lang="en-GB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</a:t>
              </a:r>
              <a:r>
                <a:rPr lang="en-GB" sz="1050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p</a:t>
              </a:r>
              <a:r>
                <a:rPr lang="en-GB" sz="105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articles/ml)</a:t>
              </a:r>
              <a:endParaRPr lang="de-DE" sz="105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44">
              <a:extLst>
                <a:ext uri="{FF2B5EF4-FFF2-40B4-BE49-F238E27FC236}">
                  <a16:creationId xmlns:a16="http://schemas.microsoft.com/office/drawing/2014/main" id="{C8ED4D79-2A3D-4780-DEE5-4CD515FA06CF}"/>
                </a:ext>
              </a:extLst>
            </p:cNvPr>
            <p:cNvSpPr txBox="1"/>
            <p:nvPr/>
          </p:nvSpPr>
          <p:spPr>
            <a:xfrm>
              <a:off x="4771280" y="2882643"/>
              <a:ext cx="2272549" cy="301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de-DE" sz="900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γδ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T cells (TPA/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ono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2 h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8" name="Textfeld 44">
              <a:extLst>
                <a:ext uri="{FF2B5EF4-FFF2-40B4-BE49-F238E27FC236}">
                  <a16:creationId xmlns:a16="http://schemas.microsoft.com/office/drawing/2014/main" id="{F45B540E-26A6-1013-5F22-8347535393C4}"/>
                </a:ext>
              </a:extLst>
            </p:cNvPr>
            <p:cNvSpPr txBox="1"/>
            <p:nvPr/>
          </p:nvSpPr>
          <p:spPr>
            <a:xfrm>
              <a:off x="7679376" y="2882643"/>
              <a:ext cx="2212162" cy="301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de-DE" sz="900" dirty="0" err="1">
                  <a:effectLst/>
                  <a:latin typeface="Arial" panose="020B0604020202020204" pitchFamily="34" charset="0"/>
                  <a:ea typeface="Calibri" panose="020F0502020204030204" pitchFamily="34" charset="0"/>
                </a:rPr>
                <a:t>γδ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T cells (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unstim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 72 h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29" name="Textfeld 44">
              <a:extLst>
                <a:ext uri="{FF2B5EF4-FFF2-40B4-BE49-F238E27FC236}">
                  <a16:creationId xmlns:a16="http://schemas.microsoft.com/office/drawing/2014/main" id="{648982B1-53DF-6120-50A6-36829BAF92AB}"/>
                </a:ext>
              </a:extLst>
            </p:cNvPr>
            <p:cNvSpPr txBox="1"/>
            <p:nvPr/>
          </p:nvSpPr>
          <p:spPr>
            <a:xfrm>
              <a:off x="4650505" y="544548"/>
              <a:ext cx="2514096" cy="301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8</a:t>
              </a:r>
              <a:r>
                <a:rPr lang="en-GB" sz="90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T cells (TPA/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iono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2 h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  <p:sp>
          <p:nvSpPr>
            <p:cNvPr id="33" name="Textfeld 44">
              <a:extLst>
                <a:ext uri="{FF2B5EF4-FFF2-40B4-BE49-F238E27FC236}">
                  <a16:creationId xmlns:a16="http://schemas.microsoft.com/office/drawing/2014/main" id="{3F9B2866-14EA-13F4-AE0B-AF011205CC1C}"/>
                </a:ext>
              </a:extLst>
            </p:cNvPr>
            <p:cNvSpPr txBox="1"/>
            <p:nvPr/>
          </p:nvSpPr>
          <p:spPr>
            <a:xfrm>
              <a:off x="7558602" y="544547"/>
              <a:ext cx="2453708" cy="30156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just"/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CD8</a:t>
              </a:r>
              <a:r>
                <a:rPr lang="en-GB" sz="900" kern="1200" baseline="300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+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 T cells (</a:t>
              </a:r>
              <a:r>
                <a:rPr lang="en-GB" sz="900" kern="1200" dirty="0" err="1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unstim</a:t>
              </a:r>
              <a:r>
                <a:rPr lang="en-GB" sz="900" kern="1200" dirty="0">
                  <a:solidFill>
                    <a:srgbClr val="000000"/>
                  </a:solidFill>
                  <a:effectLst/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. 72 h)</a:t>
              </a:r>
              <a:endParaRPr lang="de-DE" sz="900" dirty="0">
                <a:effectLst/>
                <a:latin typeface="Arial" panose="020B0604020202020204" pitchFamily="34" charset="0"/>
                <a:ea typeface="Times New Roman" panose="02020603050405020304" pitchFamily="18" charset="0"/>
                <a:cs typeface="Arial" panose="020B0604020202020204" pitchFamily="34" charset="0"/>
              </a:endParaRPr>
            </a:p>
          </p:txBody>
        </p:sp>
      </p:grpSp>
      <p:sp>
        <p:nvSpPr>
          <p:cNvPr id="35" name="Textfeld 34">
            <a:extLst>
              <a:ext uri="{FF2B5EF4-FFF2-40B4-BE49-F238E27FC236}">
                <a16:creationId xmlns:a16="http://schemas.microsoft.com/office/drawing/2014/main" id="{CE215443-3496-AB66-8F73-DA56893A056F}"/>
              </a:ext>
            </a:extLst>
          </p:cNvPr>
          <p:cNvSpPr txBox="1"/>
          <p:nvPr/>
        </p:nvSpPr>
        <p:spPr>
          <a:xfrm>
            <a:off x="651685" y="5338803"/>
            <a:ext cx="5535555" cy="106182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just"/>
            <a:r>
              <a:rPr lang="en-GB" sz="900" b="1" dirty="0">
                <a:latin typeface="Palatino Linotype" panose="02040502050505030304" pitchFamily="18" charset="0"/>
                <a:cs typeface="Arial" panose="020B0604020202020204" pitchFamily="34" charset="0"/>
              </a:rPr>
              <a:t>Supplementary </a:t>
            </a:r>
            <a:r>
              <a:rPr lang="en-GB" sz="900" b="1">
                <a:latin typeface="Palatino Linotype" panose="02040502050505030304" pitchFamily="18" charset="0"/>
                <a:cs typeface="Arial" panose="020B0604020202020204" pitchFamily="34" charset="0"/>
              </a:rPr>
              <a:t>Figure S2 </a:t>
            </a:r>
            <a:r>
              <a:rPr lang="en-GB" sz="900" dirty="0">
                <a:latin typeface="Palatino Linotype" panose="02040502050505030304" pitchFamily="18" charset="0"/>
                <a:cs typeface="Arial" panose="020B0604020202020204" pitchFamily="34" charset="0"/>
              </a:rPr>
              <a:t>– Representative nanoparticle tracking analyses (NTAs) of enriched EVs from 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PHA-expanded CD8</a:t>
            </a:r>
            <a:r>
              <a:rPr lang="en-US" sz="900" baseline="300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+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</a:t>
            </a:r>
            <a:r>
              <a:rPr lang="de-DE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αβ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T cells (upper graphs) and zoledronate-expanded </a:t>
            </a:r>
            <a:r>
              <a:rPr lang="de-DE" sz="900" dirty="0" err="1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γδ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 T cells (lower graphs</a:t>
            </a:r>
            <a:r>
              <a:rPr lang="en-US" sz="900" dirty="0">
                <a:latin typeface="Palatino Linotype" panose="02040502050505030304" pitchFamily="18" charset="0"/>
                <a:ea typeface="Calibri" panose="020F0502020204030204" pitchFamily="34" charset="0"/>
              </a:rPr>
              <a:t>). EVs were isolated from unstimulated cells or cells that were treated with TPA and ionomycin two hours after transfer to EV-reduced medium with IL-2. Alternatively, cells were kept for 72 hours in EV-reduced medium with IL-2 to get constitutively released EVs. Overlay plots are depicted for four individual tracking measurements per sample. I</a:t>
            </a:r>
            <a:r>
              <a:rPr lang="en-US" sz="900" dirty="0">
                <a:effectLst/>
                <a:latin typeface="Palatino Linotype" panose="02040502050505030304" pitchFamily="18" charset="0"/>
                <a:ea typeface="Calibri" panose="020F0502020204030204" pitchFamily="34" charset="0"/>
              </a:rPr>
              <a:t>ndividual EV preparations are homogeneous and monodisperse presenting peaks of small extracellular vesicles of less than 200 nm in size. </a:t>
            </a:r>
            <a:endParaRPr lang="de-DE" sz="900" dirty="0">
              <a:latin typeface="Palatino Linotype" panose="0204050205050503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97586606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ppt/theme/theme2.xml><?xml version="1.0" encoding="utf-8"?>
<a:theme xmlns:a="http://schemas.openxmlformats.org/drawingml/2006/main" name="Office">
  <a:themeElements>
    <a:clrScheme name="Office">
      <a:dk1>
        <a:sysClr val="windowText" lastClr="000000"/>
      </a:dk1>
      <a:lt1>
        <a:sysClr val="window" lastClr="FFFFFF"/>
      </a:lt1>
      <a:dk2>
        <a:srgbClr val="0E2841"/>
      </a:dk2>
      <a:lt2>
        <a:srgbClr val="E8E8E8"/>
      </a:lt2>
      <a:accent1>
        <a:srgbClr val="156082"/>
      </a:accent1>
      <a:accent2>
        <a:srgbClr val="E97132"/>
      </a:accent2>
      <a:accent3>
        <a:srgbClr val="196B24"/>
      </a:accent3>
      <a:accent4>
        <a:srgbClr val="0F9ED5"/>
      </a:accent4>
      <a:accent5>
        <a:srgbClr val="A02B93"/>
      </a:accent5>
      <a:accent6>
        <a:srgbClr val="4EA72E"/>
      </a:accent6>
      <a:hlink>
        <a:srgbClr val="467886"/>
      </a:hlink>
      <a:folHlink>
        <a:srgbClr val="96607D"/>
      </a:folHlink>
    </a:clrScheme>
    <a:fontScheme name="Office">
      <a:majorFont>
        <a:latin typeface="Aptos Display" panose="0211000402020202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Aptos" panose="0211000402020202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  <a:ln w="2540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Office Theme" id="{2E142A2C-CD16-42D6-873A-C26D2A0506FA}" vid="{1BDDFF52-6CD6-40A5-AB3C-68EB2F1E4D0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181</Words>
  <Application>Microsoft Office PowerPoint</Application>
  <PresentationFormat>A4-Papier (210 x 297 mm)</PresentationFormat>
  <Paragraphs>10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4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6" baseType="lpstr">
      <vt:lpstr>Aptos</vt:lpstr>
      <vt:lpstr>Aptos Display</vt:lpstr>
      <vt:lpstr>Arial</vt:lpstr>
      <vt:lpstr>Palatino Linotype</vt:lpstr>
      <vt:lpstr>Office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Ottmar Janssen</dc:creator>
  <cp:lastModifiedBy>Ottmar Janssen</cp:lastModifiedBy>
  <cp:revision>5</cp:revision>
  <dcterms:created xsi:type="dcterms:W3CDTF">2024-08-15T13:45:21Z</dcterms:created>
  <dcterms:modified xsi:type="dcterms:W3CDTF">2024-10-16T13:34:41Z</dcterms:modified>
</cp:coreProperties>
</file>